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57" r:id="rId2"/>
    <p:sldId id="256" r:id="rId3"/>
    <p:sldId id="258" r:id="rId4"/>
    <p:sldId id="259" r:id="rId5"/>
  </p:sldIdLst>
  <p:sldSz cx="12192000" cy="6858000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4062E1B-1FC4-4711-A209-895590740E7E}" v="38" dt="2025-09-22T09:43:24.44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83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ensaku Kasuga" userId="bfc7c102b7cf7b58" providerId="LiveId" clId="{7F4B3B56-A57A-4117-9A36-ADD9987E8EA6}"/>
    <pc:docChg chg="undo custSel addSld modSld sldOrd modNotesMaster">
      <pc:chgData name="Kensaku Kasuga" userId="bfc7c102b7cf7b58" providerId="LiveId" clId="{7F4B3B56-A57A-4117-9A36-ADD9987E8EA6}" dt="2025-09-22T10:33:42.992" v="1366" actId="20577"/>
      <pc:docMkLst>
        <pc:docMk/>
      </pc:docMkLst>
      <pc:sldChg chg="addSp delSp modSp mod ord">
        <pc:chgData name="Kensaku Kasuga" userId="bfc7c102b7cf7b58" providerId="LiveId" clId="{7F4B3B56-A57A-4117-9A36-ADD9987E8EA6}" dt="2025-09-22T10:33:42.992" v="1366" actId="20577"/>
        <pc:sldMkLst>
          <pc:docMk/>
          <pc:sldMk cId="3802931744" sldId="256"/>
        </pc:sldMkLst>
        <pc:spChg chg="mod">
          <ac:chgData name="Kensaku Kasuga" userId="bfc7c102b7cf7b58" providerId="LiveId" clId="{7F4B3B56-A57A-4117-9A36-ADD9987E8EA6}" dt="2025-09-22T10:33:42.992" v="1366" actId="20577"/>
          <ac:spMkLst>
            <pc:docMk/>
            <pc:sldMk cId="3802931744" sldId="256"/>
            <ac:spMk id="2" creationId="{BC87935F-48A6-B181-5918-9C0631CDFCF7}"/>
          </ac:spMkLst>
        </pc:spChg>
        <pc:spChg chg="del">
          <ac:chgData name="Kensaku Kasuga" userId="bfc7c102b7cf7b58" providerId="LiveId" clId="{7F4B3B56-A57A-4117-9A36-ADD9987E8EA6}" dt="2025-09-22T07:12:51.107" v="6" actId="478"/>
          <ac:spMkLst>
            <pc:docMk/>
            <pc:sldMk cId="3802931744" sldId="256"/>
            <ac:spMk id="4" creationId="{0A6D8C2F-4A03-6C7A-B447-BC95498357D0}"/>
          </ac:spMkLst>
        </pc:spChg>
        <pc:spChg chg="add del mod">
          <ac:chgData name="Kensaku Kasuga" userId="bfc7c102b7cf7b58" providerId="LiveId" clId="{7F4B3B56-A57A-4117-9A36-ADD9987E8EA6}" dt="2025-09-22T08:01:23.948" v="224" actId="478"/>
          <ac:spMkLst>
            <pc:docMk/>
            <pc:sldMk cId="3802931744" sldId="256"/>
            <ac:spMk id="6" creationId="{E028CA9F-6D88-60CA-521D-2BFF5ADAC9D5}"/>
          </ac:spMkLst>
        </pc:spChg>
        <pc:spChg chg="del">
          <ac:chgData name="Kensaku Kasuga" userId="bfc7c102b7cf7b58" providerId="LiveId" clId="{7F4B3B56-A57A-4117-9A36-ADD9987E8EA6}" dt="2025-09-22T07:12:51.107" v="6" actId="478"/>
          <ac:spMkLst>
            <pc:docMk/>
            <pc:sldMk cId="3802931744" sldId="256"/>
            <ac:spMk id="7" creationId="{B7F0F543-0577-72CF-38CB-E14810E85444}"/>
          </ac:spMkLst>
        </pc:spChg>
        <pc:spChg chg="del">
          <ac:chgData name="Kensaku Kasuga" userId="bfc7c102b7cf7b58" providerId="LiveId" clId="{7F4B3B56-A57A-4117-9A36-ADD9987E8EA6}" dt="2025-09-22T07:12:51.107" v="6" actId="478"/>
          <ac:spMkLst>
            <pc:docMk/>
            <pc:sldMk cId="3802931744" sldId="256"/>
            <ac:spMk id="8" creationId="{D3766D11-D2E1-E46E-6C84-14D90FF83AD4}"/>
          </ac:spMkLst>
        </pc:spChg>
        <pc:spChg chg="add mod">
          <ac:chgData name="Kensaku Kasuga" userId="bfc7c102b7cf7b58" providerId="LiveId" clId="{7F4B3B56-A57A-4117-9A36-ADD9987E8EA6}" dt="2025-09-22T08:32:14.312" v="817" actId="1036"/>
          <ac:spMkLst>
            <pc:docMk/>
            <pc:sldMk cId="3802931744" sldId="256"/>
            <ac:spMk id="9" creationId="{42803804-3C61-C395-3671-096D1A1B4110}"/>
          </ac:spMkLst>
        </pc:spChg>
        <pc:spChg chg="del">
          <ac:chgData name="Kensaku Kasuga" userId="bfc7c102b7cf7b58" providerId="LiveId" clId="{7F4B3B56-A57A-4117-9A36-ADD9987E8EA6}" dt="2025-09-22T08:31:16.054" v="779" actId="478"/>
          <ac:spMkLst>
            <pc:docMk/>
            <pc:sldMk cId="3802931744" sldId="256"/>
            <ac:spMk id="12" creationId="{FE427913-5174-61C4-CBD8-06F1067ABA47}"/>
          </ac:spMkLst>
        </pc:spChg>
        <pc:spChg chg="add del mod">
          <ac:chgData name="Kensaku Kasuga" userId="bfc7c102b7cf7b58" providerId="LiveId" clId="{7F4B3B56-A57A-4117-9A36-ADD9987E8EA6}" dt="2025-09-22T08:01:51.040" v="243" actId="478"/>
          <ac:spMkLst>
            <pc:docMk/>
            <pc:sldMk cId="3802931744" sldId="256"/>
            <ac:spMk id="13" creationId="{5718D1C3-5AD7-2063-A594-35055DC80965}"/>
          </ac:spMkLst>
        </pc:spChg>
        <pc:spChg chg="add del mod">
          <ac:chgData name="Kensaku Kasuga" userId="bfc7c102b7cf7b58" providerId="LiveId" clId="{7F4B3B56-A57A-4117-9A36-ADD9987E8EA6}" dt="2025-09-22T08:01:51.040" v="243" actId="478"/>
          <ac:spMkLst>
            <pc:docMk/>
            <pc:sldMk cId="3802931744" sldId="256"/>
            <ac:spMk id="14" creationId="{6F8D007B-47C9-DC51-1288-746D14F27792}"/>
          </ac:spMkLst>
        </pc:spChg>
        <pc:spChg chg="add mod">
          <ac:chgData name="Kensaku Kasuga" userId="bfc7c102b7cf7b58" providerId="LiveId" clId="{7F4B3B56-A57A-4117-9A36-ADD9987E8EA6}" dt="2025-09-22T08:33:01.087" v="828" actId="1036"/>
          <ac:spMkLst>
            <pc:docMk/>
            <pc:sldMk cId="3802931744" sldId="256"/>
            <ac:spMk id="17" creationId="{C55F10EB-DBEA-C2A6-09D8-979C5A641CE4}"/>
          </ac:spMkLst>
        </pc:spChg>
        <pc:spChg chg="add del mod">
          <ac:chgData name="Kensaku Kasuga" userId="bfc7c102b7cf7b58" providerId="LiveId" clId="{7F4B3B56-A57A-4117-9A36-ADD9987E8EA6}" dt="2025-09-22T08:02:09.432" v="250" actId="478"/>
          <ac:spMkLst>
            <pc:docMk/>
            <pc:sldMk cId="3802931744" sldId="256"/>
            <ac:spMk id="18" creationId="{49B81ED9-761A-8DB5-ABAB-39250B3FAD49}"/>
          </ac:spMkLst>
        </pc:spChg>
        <pc:spChg chg="add mod">
          <ac:chgData name="Kensaku Kasuga" userId="bfc7c102b7cf7b58" providerId="LiveId" clId="{7F4B3B56-A57A-4117-9A36-ADD9987E8EA6}" dt="2025-09-22T08:32:14.312" v="817" actId="1036"/>
          <ac:spMkLst>
            <pc:docMk/>
            <pc:sldMk cId="3802931744" sldId="256"/>
            <ac:spMk id="26" creationId="{F4B3C3BE-E27D-7E2D-8C81-55EB9E8D4E3F}"/>
          </ac:spMkLst>
        </pc:spChg>
        <pc:spChg chg="add mod">
          <ac:chgData name="Kensaku Kasuga" userId="bfc7c102b7cf7b58" providerId="LiveId" clId="{7F4B3B56-A57A-4117-9A36-ADD9987E8EA6}" dt="2025-09-22T08:33:01.087" v="828" actId="1036"/>
          <ac:spMkLst>
            <pc:docMk/>
            <pc:sldMk cId="3802931744" sldId="256"/>
            <ac:spMk id="27" creationId="{BE11D1BC-DB5F-0C23-E448-E89BE4875DBE}"/>
          </ac:spMkLst>
        </pc:spChg>
        <pc:spChg chg="add mod">
          <ac:chgData name="Kensaku Kasuga" userId="bfc7c102b7cf7b58" providerId="LiveId" clId="{7F4B3B56-A57A-4117-9A36-ADD9987E8EA6}" dt="2025-09-22T08:37:54.742" v="882" actId="1035"/>
          <ac:spMkLst>
            <pc:docMk/>
            <pc:sldMk cId="3802931744" sldId="256"/>
            <ac:spMk id="28" creationId="{EA41FBB4-CDCE-A618-4A4C-5E60077344B9}"/>
          </ac:spMkLst>
        </pc:spChg>
        <pc:spChg chg="add mod">
          <ac:chgData name="Kensaku Kasuga" userId="bfc7c102b7cf7b58" providerId="LiveId" clId="{7F4B3B56-A57A-4117-9A36-ADD9987E8EA6}" dt="2025-09-22T08:32:14.312" v="817" actId="1036"/>
          <ac:spMkLst>
            <pc:docMk/>
            <pc:sldMk cId="3802931744" sldId="256"/>
            <ac:spMk id="29" creationId="{77B65066-D91F-EDDD-AE83-A20E7048AAA2}"/>
          </ac:spMkLst>
        </pc:spChg>
        <pc:spChg chg="add mod">
          <ac:chgData name="Kensaku Kasuga" userId="bfc7c102b7cf7b58" providerId="LiveId" clId="{7F4B3B56-A57A-4117-9A36-ADD9987E8EA6}" dt="2025-09-22T08:38:08.342" v="887" actId="1035"/>
          <ac:spMkLst>
            <pc:docMk/>
            <pc:sldMk cId="3802931744" sldId="256"/>
            <ac:spMk id="30" creationId="{F9201139-E0CB-DF24-864E-68F8B68AFA7D}"/>
          </ac:spMkLst>
        </pc:spChg>
        <pc:spChg chg="add mod">
          <ac:chgData name="Kensaku Kasuga" userId="bfc7c102b7cf7b58" providerId="LiveId" clId="{7F4B3B56-A57A-4117-9A36-ADD9987E8EA6}" dt="2025-09-22T08:33:01.087" v="828" actId="1036"/>
          <ac:spMkLst>
            <pc:docMk/>
            <pc:sldMk cId="3802931744" sldId="256"/>
            <ac:spMk id="31" creationId="{8E3476A8-DD58-2792-D6FA-B20646B08C25}"/>
          </ac:spMkLst>
        </pc:spChg>
        <pc:picChg chg="del">
          <ac:chgData name="Kensaku Kasuga" userId="bfc7c102b7cf7b58" providerId="LiveId" clId="{7F4B3B56-A57A-4117-9A36-ADD9987E8EA6}" dt="2025-09-22T07:12:51.107" v="6" actId="478"/>
          <ac:picMkLst>
            <pc:docMk/>
            <pc:sldMk cId="3802931744" sldId="256"/>
            <ac:picMk id="3" creationId="{13378673-4EDC-91A7-7C48-B79249A143DB}"/>
          </ac:picMkLst>
        </pc:picChg>
        <pc:picChg chg="add del mod">
          <ac:chgData name="Kensaku Kasuga" userId="bfc7c102b7cf7b58" providerId="LiveId" clId="{7F4B3B56-A57A-4117-9A36-ADD9987E8EA6}" dt="2025-09-22T07:56:54.376" v="140" actId="478"/>
          <ac:picMkLst>
            <pc:docMk/>
            <pc:sldMk cId="3802931744" sldId="256"/>
            <ac:picMk id="4" creationId="{04A52985-74C1-027E-0CA9-A09E11B417AA}"/>
          </ac:picMkLst>
        </pc:picChg>
        <pc:picChg chg="add del mod">
          <ac:chgData name="Kensaku Kasuga" userId="bfc7c102b7cf7b58" providerId="LiveId" clId="{7F4B3B56-A57A-4117-9A36-ADD9987E8EA6}" dt="2025-09-22T07:58:02.962" v="150" actId="478"/>
          <ac:picMkLst>
            <pc:docMk/>
            <pc:sldMk cId="3802931744" sldId="256"/>
            <ac:picMk id="5" creationId="{0CA18A60-C351-44A8-F900-9CD756B61676}"/>
          </ac:picMkLst>
        </pc:picChg>
        <pc:picChg chg="add mod modCrop">
          <ac:chgData name="Kensaku Kasuga" userId="bfc7c102b7cf7b58" providerId="LiveId" clId="{7F4B3B56-A57A-4117-9A36-ADD9987E8EA6}" dt="2025-09-22T08:33:01.087" v="828" actId="1036"/>
          <ac:picMkLst>
            <pc:docMk/>
            <pc:sldMk cId="3802931744" sldId="256"/>
            <ac:picMk id="8" creationId="{885245E8-B661-55CF-532D-25E32580C88E}"/>
          </ac:picMkLst>
        </pc:picChg>
        <pc:picChg chg="add mod">
          <ac:chgData name="Kensaku Kasuga" userId="bfc7c102b7cf7b58" providerId="LiveId" clId="{7F4B3B56-A57A-4117-9A36-ADD9987E8EA6}" dt="2025-09-22T08:32:14.312" v="817" actId="1036"/>
          <ac:picMkLst>
            <pc:docMk/>
            <pc:sldMk cId="3802931744" sldId="256"/>
            <ac:picMk id="10" creationId="{0011CBA5-7C40-368E-718D-F45E752B9C3F}"/>
          </ac:picMkLst>
        </pc:picChg>
        <pc:picChg chg="add del mod">
          <ac:chgData name="Kensaku Kasuga" userId="bfc7c102b7cf7b58" providerId="LiveId" clId="{7F4B3B56-A57A-4117-9A36-ADD9987E8EA6}" dt="2025-09-22T07:58:02.962" v="150" actId="478"/>
          <ac:picMkLst>
            <pc:docMk/>
            <pc:sldMk cId="3802931744" sldId="256"/>
            <ac:picMk id="11" creationId="{90626014-44DF-AA6F-84F3-1401883C4B12}"/>
          </ac:picMkLst>
        </pc:picChg>
        <pc:picChg chg="add del mod">
          <ac:chgData name="Kensaku Kasuga" userId="bfc7c102b7cf7b58" providerId="LiveId" clId="{7F4B3B56-A57A-4117-9A36-ADD9987E8EA6}" dt="2025-09-22T07:58:14.182" v="154" actId="478"/>
          <ac:picMkLst>
            <pc:docMk/>
            <pc:sldMk cId="3802931744" sldId="256"/>
            <ac:picMk id="15" creationId="{BDC50496-2336-D249-785E-BF92A58C6FC8}"/>
          </ac:picMkLst>
        </pc:picChg>
        <pc:picChg chg="add del mod">
          <ac:chgData name="Kensaku Kasuga" userId="bfc7c102b7cf7b58" providerId="LiveId" clId="{7F4B3B56-A57A-4117-9A36-ADD9987E8EA6}" dt="2025-09-22T07:58:02.962" v="150" actId="478"/>
          <ac:picMkLst>
            <pc:docMk/>
            <pc:sldMk cId="3802931744" sldId="256"/>
            <ac:picMk id="16" creationId="{012EC6C2-9DD3-51C9-DB79-088DDDC152BE}"/>
          </ac:picMkLst>
        </pc:picChg>
        <pc:picChg chg="add del mod">
          <ac:chgData name="Kensaku Kasuga" userId="bfc7c102b7cf7b58" providerId="LiveId" clId="{7F4B3B56-A57A-4117-9A36-ADD9987E8EA6}" dt="2025-09-22T07:58:14.182" v="154" actId="478"/>
          <ac:picMkLst>
            <pc:docMk/>
            <pc:sldMk cId="3802931744" sldId="256"/>
            <ac:picMk id="19" creationId="{9886EFBA-C0BC-91C1-0174-C549C6DBDD9F}"/>
          </ac:picMkLst>
        </pc:picChg>
        <pc:picChg chg="add mod modCrop">
          <ac:chgData name="Kensaku Kasuga" userId="bfc7c102b7cf7b58" providerId="LiveId" clId="{7F4B3B56-A57A-4117-9A36-ADD9987E8EA6}" dt="2025-09-22T08:30:34.452" v="752" actId="1035"/>
          <ac:picMkLst>
            <pc:docMk/>
            <pc:sldMk cId="3802931744" sldId="256"/>
            <ac:picMk id="21" creationId="{7083936F-1189-AFC8-25EE-BC627175C35D}"/>
          </ac:picMkLst>
        </pc:picChg>
        <pc:picChg chg="add mod modCrop">
          <ac:chgData name="Kensaku Kasuga" userId="bfc7c102b7cf7b58" providerId="LiveId" clId="{7F4B3B56-A57A-4117-9A36-ADD9987E8EA6}" dt="2025-09-22T08:33:01.087" v="828" actId="1036"/>
          <ac:picMkLst>
            <pc:docMk/>
            <pc:sldMk cId="3802931744" sldId="256"/>
            <ac:picMk id="23" creationId="{E3F708E5-6160-1C71-3A5E-4EA3ED88D434}"/>
          </ac:picMkLst>
        </pc:picChg>
        <pc:picChg chg="add mod modCrop">
          <ac:chgData name="Kensaku Kasuga" userId="bfc7c102b7cf7b58" providerId="LiveId" clId="{7F4B3B56-A57A-4117-9A36-ADD9987E8EA6}" dt="2025-09-22T08:30:34.452" v="752" actId="1035"/>
          <ac:picMkLst>
            <pc:docMk/>
            <pc:sldMk cId="3802931744" sldId="256"/>
            <ac:picMk id="25" creationId="{09B6AFA2-309D-8E11-2E60-7F7C032EDA76}"/>
          </ac:picMkLst>
        </pc:picChg>
      </pc:sldChg>
      <pc:sldChg chg="addSp delSp modSp add mod">
        <pc:chgData name="Kensaku Kasuga" userId="bfc7c102b7cf7b58" providerId="LiveId" clId="{7F4B3B56-A57A-4117-9A36-ADD9987E8EA6}" dt="2025-09-22T10:33:37.042" v="1365" actId="20577"/>
        <pc:sldMkLst>
          <pc:docMk/>
          <pc:sldMk cId="3955744923" sldId="257"/>
        </pc:sldMkLst>
        <pc:spChg chg="mod">
          <ac:chgData name="Kensaku Kasuga" userId="bfc7c102b7cf7b58" providerId="LiveId" clId="{7F4B3B56-A57A-4117-9A36-ADD9987E8EA6}" dt="2025-09-22T10:33:37.042" v="1365" actId="20577"/>
          <ac:spMkLst>
            <pc:docMk/>
            <pc:sldMk cId="3955744923" sldId="257"/>
            <ac:spMk id="2" creationId="{C219D46A-4EC3-61C4-2834-827646B59E99}"/>
          </ac:spMkLst>
        </pc:spChg>
        <pc:spChg chg="del">
          <ac:chgData name="Kensaku Kasuga" userId="bfc7c102b7cf7b58" providerId="LiveId" clId="{7F4B3B56-A57A-4117-9A36-ADD9987E8EA6}" dt="2025-09-22T07:14:44.836" v="65" actId="478"/>
          <ac:spMkLst>
            <pc:docMk/>
            <pc:sldMk cId="3955744923" sldId="257"/>
            <ac:spMk id="4" creationId="{A82562C7-FB58-C77A-F283-AA6FA3EB3CAC}"/>
          </ac:spMkLst>
        </pc:spChg>
        <pc:spChg chg="add mod">
          <ac:chgData name="Kensaku Kasuga" userId="bfc7c102b7cf7b58" providerId="LiveId" clId="{7F4B3B56-A57A-4117-9A36-ADD9987E8EA6}" dt="2025-09-22T09:40:05.692" v="1361" actId="20577"/>
          <ac:spMkLst>
            <pc:docMk/>
            <pc:sldMk cId="3955744923" sldId="257"/>
            <ac:spMk id="5" creationId="{27F0D29E-5111-C867-8511-E92F4FE19D6E}"/>
          </ac:spMkLst>
        </pc:spChg>
        <pc:spChg chg="add mod">
          <ac:chgData name="Kensaku Kasuga" userId="bfc7c102b7cf7b58" providerId="LiveId" clId="{7F4B3B56-A57A-4117-9A36-ADD9987E8EA6}" dt="2025-09-22T09:07:42.352" v="961" actId="552"/>
          <ac:spMkLst>
            <pc:docMk/>
            <pc:sldMk cId="3955744923" sldId="257"/>
            <ac:spMk id="6" creationId="{8209E669-1047-1B0D-24F9-B63B87C5C361}"/>
          </ac:spMkLst>
        </pc:spChg>
        <pc:spChg chg="del">
          <ac:chgData name="Kensaku Kasuga" userId="bfc7c102b7cf7b58" providerId="LiveId" clId="{7F4B3B56-A57A-4117-9A36-ADD9987E8EA6}" dt="2025-09-22T07:14:44.836" v="65" actId="478"/>
          <ac:spMkLst>
            <pc:docMk/>
            <pc:sldMk cId="3955744923" sldId="257"/>
            <ac:spMk id="7" creationId="{ECD9CD43-376A-63FF-E613-4F4EDD78128D}"/>
          </ac:spMkLst>
        </pc:spChg>
        <pc:spChg chg="del">
          <ac:chgData name="Kensaku Kasuga" userId="bfc7c102b7cf7b58" providerId="LiveId" clId="{7F4B3B56-A57A-4117-9A36-ADD9987E8EA6}" dt="2025-09-22T07:14:44.836" v="65" actId="478"/>
          <ac:spMkLst>
            <pc:docMk/>
            <pc:sldMk cId="3955744923" sldId="257"/>
            <ac:spMk id="8" creationId="{48443707-118C-AF35-B5D9-0D4F08E5DB4E}"/>
          </ac:spMkLst>
        </pc:spChg>
        <pc:spChg chg="add mod">
          <ac:chgData name="Kensaku Kasuga" userId="bfc7c102b7cf7b58" providerId="LiveId" clId="{7F4B3B56-A57A-4117-9A36-ADD9987E8EA6}" dt="2025-09-22T07:16:17.182" v="108" actId="20577"/>
          <ac:spMkLst>
            <pc:docMk/>
            <pc:sldMk cId="3955744923" sldId="257"/>
            <ac:spMk id="9" creationId="{62D67CFC-9D97-849A-0AA6-02B86EB13A4F}"/>
          </ac:spMkLst>
        </pc:spChg>
        <pc:spChg chg="add mod">
          <ac:chgData name="Kensaku Kasuga" userId="bfc7c102b7cf7b58" providerId="LiveId" clId="{7F4B3B56-A57A-4117-9A36-ADD9987E8EA6}" dt="2025-09-22T09:07:51.232" v="963" actId="552"/>
          <ac:spMkLst>
            <pc:docMk/>
            <pc:sldMk cId="3955744923" sldId="257"/>
            <ac:spMk id="10" creationId="{36422300-8386-9441-5159-DF65A9442011}"/>
          </ac:spMkLst>
        </pc:spChg>
        <pc:spChg chg="add del mod">
          <ac:chgData name="Kensaku Kasuga" userId="bfc7c102b7cf7b58" providerId="LiveId" clId="{7F4B3B56-A57A-4117-9A36-ADD9987E8EA6}" dt="2025-09-22T09:05:45.426" v="901" actId="478"/>
          <ac:spMkLst>
            <pc:docMk/>
            <pc:sldMk cId="3955744923" sldId="257"/>
            <ac:spMk id="11" creationId="{760B22C4-152C-D23A-6FDA-64C2A8B30CD8}"/>
          </ac:spMkLst>
        </pc:spChg>
        <pc:spChg chg="del mod">
          <ac:chgData name="Kensaku Kasuga" userId="bfc7c102b7cf7b58" providerId="LiveId" clId="{7F4B3B56-A57A-4117-9A36-ADD9987E8EA6}" dt="2025-09-22T09:33:08.258" v="1184" actId="478"/>
          <ac:spMkLst>
            <pc:docMk/>
            <pc:sldMk cId="3955744923" sldId="257"/>
            <ac:spMk id="12" creationId="{7B70A0D8-0D98-EA10-9A46-E839645B80F6}"/>
          </ac:spMkLst>
        </pc:spChg>
        <pc:spChg chg="add del mod">
          <ac:chgData name="Kensaku Kasuga" userId="bfc7c102b7cf7b58" providerId="LiveId" clId="{7F4B3B56-A57A-4117-9A36-ADD9987E8EA6}" dt="2025-09-22T09:05:45.426" v="901" actId="478"/>
          <ac:spMkLst>
            <pc:docMk/>
            <pc:sldMk cId="3955744923" sldId="257"/>
            <ac:spMk id="13" creationId="{892812BD-0308-CDE0-82EA-BBCA02AF609A}"/>
          </ac:spMkLst>
        </pc:spChg>
        <pc:spChg chg="add del mod">
          <ac:chgData name="Kensaku Kasuga" userId="bfc7c102b7cf7b58" providerId="LiveId" clId="{7F4B3B56-A57A-4117-9A36-ADD9987E8EA6}" dt="2025-09-22T09:05:45.426" v="901" actId="478"/>
          <ac:spMkLst>
            <pc:docMk/>
            <pc:sldMk cId="3955744923" sldId="257"/>
            <ac:spMk id="14" creationId="{0C749E1B-8FFB-6DFF-885E-B3814A5D1050}"/>
          </ac:spMkLst>
        </pc:spChg>
        <pc:spChg chg="add del mod">
          <ac:chgData name="Kensaku Kasuga" userId="bfc7c102b7cf7b58" providerId="LiveId" clId="{7F4B3B56-A57A-4117-9A36-ADD9987E8EA6}" dt="2025-09-22T09:05:45.426" v="901" actId="478"/>
          <ac:spMkLst>
            <pc:docMk/>
            <pc:sldMk cId="3955744923" sldId="257"/>
            <ac:spMk id="15" creationId="{FBE15CFC-934A-FB65-0A1A-B36594AF9FBF}"/>
          </ac:spMkLst>
        </pc:spChg>
        <pc:spChg chg="add mod">
          <ac:chgData name="Kensaku Kasuga" userId="bfc7c102b7cf7b58" providerId="LiveId" clId="{7F4B3B56-A57A-4117-9A36-ADD9987E8EA6}" dt="2025-09-22T09:16:24.333" v="1129" actId="554"/>
          <ac:spMkLst>
            <pc:docMk/>
            <pc:sldMk cId="3955744923" sldId="257"/>
            <ac:spMk id="20" creationId="{2E1D91C5-410F-2EE0-110D-4799A13E51D9}"/>
          </ac:spMkLst>
        </pc:spChg>
        <pc:spChg chg="add mod">
          <ac:chgData name="Kensaku Kasuga" userId="bfc7c102b7cf7b58" providerId="LiveId" clId="{7F4B3B56-A57A-4117-9A36-ADD9987E8EA6}" dt="2025-09-22T09:16:04.283" v="1070" actId="554"/>
          <ac:spMkLst>
            <pc:docMk/>
            <pc:sldMk cId="3955744923" sldId="257"/>
            <ac:spMk id="21" creationId="{6C063E9C-23BE-26F4-61B6-F690AE96480D}"/>
          </ac:spMkLst>
        </pc:spChg>
        <pc:spChg chg="add mod">
          <ac:chgData name="Kensaku Kasuga" userId="bfc7c102b7cf7b58" providerId="LiveId" clId="{7F4B3B56-A57A-4117-9A36-ADD9987E8EA6}" dt="2025-09-22T09:17:21.684" v="1154" actId="20577"/>
          <ac:spMkLst>
            <pc:docMk/>
            <pc:sldMk cId="3955744923" sldId="257"/>
            <ac:spMk id="22" creationId="{DB4AF804-F3F6-4701-1110-29A7A49D3550}"/>
          </ac:spMkLst>
        </pc:spChg>
        <pc:spChg chg="add mod">
          <ac:chgData name="Kensaku Kasuga" userId="bfc7c102b7cf7b58" providerId="LiveId" clId="{7F4B3B56-A57A-4117-9A36-ADD9987E8EA6}" dt="2025-09-22T09:17:36.892" v="1160" actId="20577"/>
          <ac:spMkLst>
            <pc:docMk/>
            <pc:sldMk cId="3955744923" sldId="257"/>
            <ac:spMk id="23" creationId="{E6E84ABE-7B5D-D41C-C7A9-8D7A0665DD63}"/>
          </ac:spMkLst>
        </pc:spChg>
        <pc:picChg chg="del">
          <ac:chgData name="Kensaku Kasuga" userId="bfc7c102b7cf7b58" providerId="LiveId" clId="{7F4B3B56-A57A-4117-9A36-ADD9987E8EA6}" dt="2025-09-22T07:14:44.836" v="65" actId="478"/>
          <ac:picMkLst>
            <pc:docMk/>
            <pc:sldMk cId="3955744923" sldId="257"/>
            <ac:picMk id="3" creationId="{A5FE87CB-8322-5059-AF72-5FE3002F4099}"/>
          </ac:picMkLst>
        </pc:picChg>
        <pc:picChg chg="add mod modCrop">
          <ac:chgData name="Kensaku Kasuga" userId="bfc7c102b7cf7b58" providerId="LiveId" clId="{7F4B3B56-A57A-4117-9A36-ADD9987E8EA6}" dt="2025-09-22T09:06:34.592" v="910" actId="732"/>
          <ac:picMkLst>
            <pc:docMk/>
            <pc:sldMk cId="3955744923" sldId="257"/>
            <ac:picMk id="4" creationId="{86FC58AF-0343-4A0D-997D-B69A8FB6F5F8}"/>
          </ac:picMkLst>
        </pc:picChg>
        <pc:picChg chg="add mod modCrop">
          <ac:chgData name="Kensaku Kasuga" userId="bfc7c102b7cf7b58" providerId="LiveId" clId="{7F4B3B56-A57A-4117-9A36-ADD9987E8EA6}" dt="2025-09-22T09:07:08.183" v="929" actId="1038"/>
          <ac:picMkLst>
            <pc:docMk/>
            <pc:sldMk cId="3955744923" sldId="257"/>
            <ac:picMk id="8" creationId="{CD502404-F6C4-B128-88B4-1540EA54FAB7}"/>
          </ac:picMkLst>
        </pc:picChg>
        <pc:picChg chg="add mod modCrop">
          <ac:chgData name="Kensaku Kasuga" userId="bfc7c102b7cf7b58" providerId="LiveId" clId="{7F4B3B56-A57A-4117-9A36-ADD9987E8EA6}" dt="2025-09-22T09:07:42.352" v="961" actId="552"/>
          <ac:picMkLst>
            <pc:docMk/>
            <pc:sldMk cId="3955744923" sldId="257"/>
            <ac:picMk id="17" creationId="{5A90B78B-85C5-C88F-234E-E18A17552D79}"/>
          </ac:picMkLst>
        </pc:picChg>
        <pc:picChg chg="add mod modCrop">
          <ac:chgData name="Kensaku Kasuga" userId="bfc7c102b7cf7b58" providerId="LiveId" clId="{7F4B3B56-A57A-4117-9A36-ADD9987E8EA6}" dt="2025-09-22T09:07:51.232" v="963" actId="552"/>
          <ac:picMkLst>
            <pc:docMk/>
            <pc:sldMk cId="3955744923" sldId="257"/>
            <ac:picMk id="19" creationId="{B96532E5-9226-768D-9C4D-1B187CBC2159}"/>
          </ac:picMkLst>
        </pc:picChg>
      </pc:sldChg>
      <pc:sldChg chg="delSp modSp add mod">
        <pc:chgData name="Kensaku Kasuga" userId="bfc7c102b7cf7b58" providerId="LiveId" clId="{7F4B3B56-A57A-4117-9A36-ADD9987E8EA6}" dt="2025-09-22T09:39:37.172" v="1337" actId="1035"/>
        <pc:sldMkLst>
          <pc:docMk/>
          <pc:sldMk cId="2485337457" sldId="258"/>
        </pc:sldMkLst>
        <pc:spChg chg="mod">
          <ac:chgData name="Kensaku Kasuga" userId="bfc7c102b7cf7b58" providerId="LiveId" clId="{7F4B3B56-A57A-4117-9A36-ADD9987E8EA6}" dt="2025-09-22T09:39:37.172" v="1337" actId="1035"/>
          <ac:spMkLst>
            <pc:docMk/>
            <pc:sldMk cId="2485337457" sldId="258"/>
            <ac:spMk id="2" creationId="{0D20AABF-1952-37B1-EDAB-DC30A11B982E}"/>
          </ac:spMkLst>
        </pc:spChg>
        <pc:spChg chg="mod">
          <ac:chgData name="Kensaku Kasuga" userId="bfc7c102b7cf7b58" providerId="LiveId" clId="{7F4B3B56-A57A-4117-9A36-ADD9987E8EA6}" dt="2025-09-22T09:33:26.872" v="1255" actId="1035"/>
          <ac:spMkLst>
            <pc:docMk/>
            <pc:sldMk cId="2485337457" sldId="258"/>
            <ac:spMk id="4" creationId="{E2FF56F6-1A0D-F1BA-7F27-D6E57C74DFF6}"/>
          </ac:spMkLst>
        </pc:spChg>
        <pc:spChg chg="mod">
          <ac:chgData name="Kensaku Kasuga" userId="bfc7c102b7cf7b58" providerId="LiveId" clId="{7F4B3B56-A57A-4117-9A36-ADD9987E8EA6}" dt="2025-09-22T09:33:26.872" v="1255" actId="1035"/>
          <ac:spMkLst>
            <pc:docMk/>
            <pc:sldMk cId="2485337457" sldId="258"/>
            <ac:spMk id="7" creationId="{5273EF8D-B15C-D5E5-B2D1-18C371913AE1}"/>
          </ac:spMkLst>
        </pc:spChg>
        <pc:spChg chg="mod">
          <ac:chgData name="Kensaku Kasuga" userId="bfc7c102b7cf7b58" providerId="LiveId" clId="{7F4B3B56-A57A-4117-9A36-ADD9987E8EA6}" dt="2025-09-22T09:33:26.872" v="1255" actId="1035"/>
          <ac:spMkLst>
            <pc:docMk/>
            <pc:sldMk cId="2485337457" sldId="258"/>
            <ac:spMk id="8" creationId="{2D8DB658-D7AF-CF6F-86D2-EF8A54A10B01}"/>
          </ac:spMkLst>
        </pc:spChg>
        <pc:spChg chg="del">
          <ac:chgData name="Kensaku Kasuga" userId="bfc7c102b7cf7b58" providerId="LiveId" clId="{7F4B3B56-A57A-4117-9A36-ADD9987E8EA6}" dt="2025-09-22T08:35:58.397" v="857" actId="478"/>
          <ac:spMkLst>
            <pc:docMk/>
            <pc:sldMk cId="2485337457" sldId="258"/>
            <ac:spMk id="12" creationId="{DFB05E7A-41E9-A722-D615-62D1DAAD72AF}"/>
          </ac:spMkLst>
        </pc:spChg>
        <pc:picChg chg="mod">
          <ac:chgData name="Kensaku Kasuga" userId="bfc7c102b7cf7b58" providerId="LiveId" clId="{7F4B3B56-A57A-4117-9A36-ADD9987E8EA6}" dt="2025-09-22T09:33:26.872" v="1255" actId="1035"/>
          <ac:picMkLst>
            <pc:docMk/>
            <pc:sldMk cId="2485337457" sldId="258"/>
            <ac:picMk id="3" creationId="{86822EED-9C3C-8C2B-D5FE-17C022B079C5}"/>
          </ac:picMkLst>
        </pc:picChg>
      </pc:sldChg>
      <pc:sldChg chg="addSp delSp modSp add mod">
        <pc:chgData name="Kensaku Kasuga" userId="bfc7c102b7cf7b58" providerId="LiveId" clId="{7F4B3B56-A57A-4117-9A36-ADD9987E8EA6}" dt="2025-09-22T09:39:10.862" v="1325" actId="1036"/>
        <pc:sldMkLst>
          <pc:docMk/>
          <pc:sldMk cId="672376758" sldId="259"/>
        </pc:sldMkLst>
        <pc:spChg chg="mod">
          <ac:chgData name="Kensaku Kasuga" userId="bfc7c102b7cf7b58" providerId="LiveId" clId="{7F4B3B56-A57A-4117-9A36-ADD9987E8EA6}" dt="2025-09-22T09:38:48.625" v="1290" actId="114"/>
          <ac:spMkLst>
            <pc:docMk/>
            <pc:sldMk cId="672376758" sldId="259"/>
            <ac:spMk id="2" creationId="{573576DE-5448-F891-5A85-2BBB3DE6CF4D}"/>
          </ac:spMkLst>
        </pc:spChg>
        <pc:spChg chg="del">
          <ac:chgData name="Kensaku Kasuga" userId="bfc7c102b7cf7b58" providerId="LiveId" clId="{7F4B3B56-A57A-4117-9A36-ADD9987E8EA6}" dt="2025-09-22T07:16:58.272" v="124" actId="478"/>
          <ac:spMkLst>
            <pc:docMk/>
            <pc:sldMk cId="672376758" sldId="259"/>
            <ac:spMk id="4" creationId="{8FD650D6-9042-08F2-7E02-9DA8A3B6FF8B}"/>
          </ac:spMkLst>
        </pc:spChg>
        <pc:spChg chg="add del mod">
          <ac:chgData name="Kensaku Kasuga" userId="bfc7c102b7cf7b58" providerId="LiveId" clId="{7F4B3B56-A57A-4117-9A36-ADD9987E8EA6}" dt="2025-09-22T09:32:40.012" v="1176" actId="478"/>
          <ac:spMkLst>
            <pc:docMk/>
            <pc:sldMk cId="672376758" sldId="259"/>
            <ac:spMk id="5" creationId="{B8C1EC3E-91F5-5953-9614-8A82B62B0F42}"/>
          </ac:spMkLst>
        </pc:spChg>
        <pc:spChg chg="add del mod">
          <ac:chgData name="Kensaku Kasuga" userId="bfc7c102b7cf7b58" providerId="LiveId" clId="{7F4B3B56-A57A-4117-9A36-ADD9987E8EA6}" dt="2025-09-22T09:37:19.162" v="1263" actId="478"/>
          <ac:spMkLst>
            <pc:docMk/>
            <pc:sldMk cId="672376758" sldId="259"/>
            <ac:spMk id="6" creationId="{150C3115-DCDC-BC82-D1B0-07144AE52CEE}"/>
          </ac:spMkLst>
        </pc:spChg>
        <pc:spChg chg="add del mod">
          <ac:chgData name="Kensaku Kasuga" userId="bfc7c102b7cf7b58" providerId="LiveId" clId="{7F4B3B56-A57A-4117-9A36-ADD9987E8EA6}" dt="2025-09-22T09:38:52.772" v="1292" actId="478"/>
          <ac:spMkLst>
            <pc:docMk/>
            <pc:sldMk cId="672376758" sldId="259"/>
            <ac:spMk id="7" creationId="{22CF21A1-F51C-08C9-4E0A-B3D539D0BC47}"/>
          </ac:spMkLst>
        </pc:spChg>
        <pc:spChg chg="del">
          <ac:chgData name="Kensaku Kasuga" userId="bfc7c102b7cf7b58" providerId="LiveId" clId="{7F4B3B56-A57A-4117-9A36-ADD9987E8EA6}" dt="2025-09-22T07:16:58.272" v="124" actId="478"/>
          <ac:spMkLst>
            <pc:docMk/>
            <pc:sldMk cId="672376758" sldId="259"/>
            <ac:spMk id="7" creationId="{F6AE4D2D-9A32-612C-D2B4-1F54C0ED4A57}"/>
          </ac:spMkLst>
        </pc:spChg>
        <pc:spChg chg="del">
          <ac:chgData name="Kensaku Kasuga" userId="bfc7c102b7cf7b58" providerId="LiveId" clId="{7F4B3B56-A57A-4117-9A36-ADD9987E8EA6}" dt="2025-09-22T07:16:58.272" v="124" actId="478"/>
          <ac:spMkLst>
            <pc:docMk/>
            <pc:sldMk cId="672376758" sldId="259"/>
            <ac:spMk id="8" creationId="{7333A9EC-A6DE-365F-050A-0A87FD1EDAC0}"/>
          </ac:spMkLst>
        </pc:spChg>
        <pc:spChg chg="del mod">
          <ac:chgData name="Kensaku Kasuga" userId="bfc7c102b7cf7b58" providerId="LiveId" clId="{7F4B3B56-A57A-4117-9A36-ADD9987E8EA6}" dt="2025-09-22T09:38:58.492" v="1293" actId="478"/>
          <ac:spMkLst>
            <pc:docMk/>
            <pc:sldMk cId="672376758" sldId="259"/>
            <ac:spMk id="12" creationId="{249B929E-9D93-97C6-8090-2EF0031DCD94}"/>
          </ac:spMkLst>
        </pc:spChg>
        <pc:picChg chg="del">
          <ac:chgData name="Kensaku Kasuga" userId="bfc7c102b7cf7b58" providerId="LiveId" clId="{7F4B3B56-A57A-4117-9A36-ADD9987E8EA6}" dt="2025-09-22T07:16:58.272" v="124" actId="478"/>
          <ac:picMkLst>
            <pc:docMk/>
            <pc:sldMk cId="672376758" sldId="259"/>
            <ac:picMk id="3" creationId="{F782AA8F-7FA9-FA61-CDE7-0D5CF34724A0}"/>
          </ac:picMkLst>
        </pc:picChg>
        <pc:picChg chg="add mod modCrop">
          <ac:chgData name="Kensaku Kasuga" userId="bfc7c102b7cf7b58" providerId="LiveId" clId="{7F4B3B56-A57A-4117-9A36-ADD9987E8EA6}" dt="2025-09-22T09:39:10.862" v="1325" actId="1036"/>
          <ac:picMkLst>
            <pc:docMk/>
            <pc:sldMk cId="672376758" sldId="259"/>
            <ac:picMk id="4" creationId="{6445610C-9E25-7E2B-68DB-0F5983085B4E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4CC095-10DF-4FCD-A425-6E0B222A8EC5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3013"/>
            <a:ext cx="5962650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0" y="4783307"/>
            <a:ext cx="5445760" cy="3913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38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3BC663-4CD4-496D-A334-142921C6EE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7876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24CA29D-FC91-952B-417C-1EAB69BFE44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5A50CC0E-B283-D558-4D44-3FDFD3C70C0E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62194DCA-3D3D-9217-F3F7-B332C4ECC839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141127B-33F8-C345-8D54-6582CA11497B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3BC663-4CD4-496D-A334-142921C6EE28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814911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3BC663-4CD4-496D-A334-142921C6EE28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715314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3F202C6-DD2F-7808-1EA8-56B72DA37BC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AF007575-1B4E-CBDF-22D5-59B117D7B038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FD3E59EF-4F84-076C-DC4F-78DF3F8B7054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F350EB0C-A359-7ADB-5641-DD2F71789E0C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3BC663-4CD4-496D-A334-142921C6EE28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951465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3F9E4E3-F34B-2262-4AA6-D7FD7147C49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57061588-703E-870D-1202-51CD1FA13519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D1011CDC-2C1D-6899-4C31-353BF7AAE094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CDD5B08A-EC41-86CD-7B49-C37CA839AE9D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3BC663-4CD4-496D-A334-142921C6EE28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49138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859C15B-6576-E904-FB52-CA0AF3E8466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909BBB3C-3282-0D05-B73A-DBA563A3661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9DE67A2-23A7-25C4-A8A0-D30BE8DAF9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48819E-00BD-450B-974F-9B22E97CC7B8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96CF1CE-E5AE-B642-9D35-D19C3E0EE7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CB4EFC9-06D3-B30E-64C9-98A22F15F2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9214-A0F7-4D8E-A355-62A148FAF2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219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98515B8-D852-010A-7366-F1014AF352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4AB6F93-86A6-4EFD-B0E6-4731650F7F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3A8829E-6163-2DF1-072E-1BC69055FA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48819E-00BD-450B-974F-9B22E97CC7B8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E15D52C-C328-C93A-07B9-2181CAF11F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FF16A61-6C07-AC57-1EF0-8445F42687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9214-A0F7-4D8E-A355-62A148FAF2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28589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434E370-906D-8B9D-5924-45C2F800E92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CFE11DB-42B0-FAFC-819D-817BEE0F31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E54DDAD-5894-9580-6841-B626944991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48819E-00BD-450B-974F-9B22E97CC7B8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B954377-9929-5AC7-F950-0777E1878A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4F314F6-6096-CA0C-C5C6-E1CCF5EFD1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9214-A0F7-4D8E-A355-62A148FAF2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40586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78F0494-DF73-CE84-72DC-D8741A19B3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A414108-607E-9AF2-98CF-EB111F7258F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2256898-76B3-0FBB-4E1C-09A1CC7525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48819E-00BD-450B-974F-9B22E97CC7B8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5BB6374-89A9-A666-7C82-E89526EA19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4A2B966-027D-55B8-6EBD-06B929F996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9214-A0F7-4D8E-A355-62A148FAF2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42128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F99FCA6-D027-94E5-3BA1-C598983389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15791BD-CBF9-7EEF-CE97-CFE0CEF99D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8CCF706-71A4-1AE6-FDAC-8630466709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48819E-00BD-450B-974F-9B22E97CC7B8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02D9A26-AA6C-0ADA-A360-EE5DACCDF7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5F0094A-C936-CA0B-61C7-DD9FB2C4B3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9214-A0F7-4D8E-A355-62A148FAF2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13099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1842E1E-D47C-5202-BA23-D406772414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D8276E0-13EA-E41E-4F5A-15ABD325752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9439E94-F05F-1903-8DF7-6BEE5B4A41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F6686D3-D7FB-BFAD-2BB0-3E15A4B45B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48819E-00BD-450B-974F-9B22E97CC7B8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5F90AB3-91A2-6CB4-6EC0-CB49DB4E98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DEE1957-CA13-C9FF-C190-88919115BA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9214-A0F7-4D8E-A355-62A148FAF2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09758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36D0567-0EE3-ABE0-3F93-733775B62D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4C1AA34-D2C7-01A8-E290-5C812AC4CE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550B45E-68B4-170D-F9D5-71E9F380615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8D20121-9E10-1683-455E-1B94F34AAE7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526DF712-15E5-EE21-20C3-33C12C6A082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C91D305E-28F8-0700-258F-50F7471AF8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48819E-00BD-450B-974F-9B22E97CC7B8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0C11E6A7-4C92-9789-C3E1-804FEBEE2A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A4AB6A46-E1A7-AD0E-D2DC-BA87BD11F3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9214-A0F7-4D8E-A355-62A148FAF2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46698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2D797B9-6E72-0F70-501F-CA837D6ED3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D27702E-CE6F-D567-7A3C-785CABDE19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48819E-00BD-450B-974F-9B22E97CC7B8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C37C99E9-E8EF-C8A8-219B-0893D0EE21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8F83369E-9056-298F-A0A2-FE3AAB3C41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9214-A0F7-4D8E-A355-62A148FAF2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97410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287DB15E-5F1D-EB61-40A6-91EA9F83A2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48819E-00BD-450B-974F-9B22E97CC7B8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6D495C72-8963-5717-C1E0-EC98821702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84C13BD1-AD8E-F5CC-828F-FFCBFBC1D5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9214-A0F7-4D8E-A355-62A148FAF2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05322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F4A64DC-3133-3A78-0583-507AD201B5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F927B76-60AB-C9C2-B6B9-643BD8BCC64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707DD95-E3A4-55A9-2942-E600E3F58F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16388EF-118F-3ADA-D653-34AC40E5AC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48819E-00BD-450B-974F-9B22E97CC7B8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2647C01-644B-B071-3239-D87A3A1382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0766502-7851-9782-CA52-7DDCDE5726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9214-A0F7-4D8E-A355-62A148FAF2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46969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AFFB500-1462-D78F-90AE-64738C9CDC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F81E13B-59F7-E598-32C1-CBDC0E63A57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kumimoji="1" lang="ja-JP" altLang="en-US"/>
              <a:t>アイコンをクリックして図を追加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77C921B-C03C-D80D-3E5D-7590DF2ADA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2930AF5-37A8-26EB-7FF4-3A8607F9A2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48819E-00BD-450B-974F-9B22E97CC7B8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645FDC5-6C88-3230-F2DE-FDD26815A9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B998C9A-C310-E455-1DC7-4B65ECF559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9214-A0F7-4D8E-A355-62A148FAF2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44478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5F0C4BB4-0C82-2494-F511-12BF8657BC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5C4AEEF-1E91-711C-298D-A084BFD634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22CF355-8A41-2145-FF83-548752775CD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48819E-00BD-450B-974F-9B22E97CC7B8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7CB6469-467F-A8CF-4FFC-E9B47BE5CA6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9FCFBE6-91A5-81DB-04C5-D7D6770E196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B89214-A0F7-4D8E-A355-62A148FAF2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2277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"/><Relationship Id="rId5" Type="http://schemas.openxmlformats.org/officeDocument/2006/relationships/image" Target="../media/image3.tif"/><Relationship Id="rId4" Type="http://schemas.openxmlformats.org/officeDocument/2006/relationships/image" Target="../media/image2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7" Type="http://schemas.openxmlformats.org/officeDocument/2006/relationships/image" Target="../media/image9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tiff"/><Relationship Id="rId5" Type="http://schemas.openxmlformats.org/officeDocument/2006/relationships/image" Target="../media/image7.tiff"/><Relationship Id="rId4" Type="http://schemas.openxmlformats.org/officeDocument/2006/relationships/image" Target="../media/image6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D4D3AA5-0584-7FA9-89A3-65AC93438AB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219D46A-4EC3-61C4-2834-827646B59E99}"/>
              </a:ext>
            </a:extLst>
          </p:cNvPr>
          <p:cNvSpPr txBox="1"/>
          <p:nvPr/>
        </p:nvSpPr>
        <p:spPr>
          <a:xfrm>
            <a:off x="0" y="4680918"/>
            <a:ext cx="12192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b="1" dirty="0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ja-JP" b="1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altLang="ja-JP" b="1" dirty="0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Association of Plasma </a:t>
            </a:r>
            <a:r>
              <a:rPr lang="en-US" altLang="ja-JP" b="1" dirty="0" err="1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GF</a:t>
            </a:r>
            <a:r>
              <a:rPr lang="en-US" altLang="ja-JP" b="1" dirty="0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Levels with Age and Sex Differences.</a:t>
            </a:r>
          </a:p>
          <a:p>
            <a:pPr algn="just"/>
            <a:r>
              <a:rPr lang="en-US" altLang="ja-JP" dirty="0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nels A and B show data from the discovery cohort; panels C and D show data from the validation cohort. Spearman’s rank correlation and Mann–Whitney U tests were performed. A significant correlation between </a:t>
            </a:r>
            <a:r>
              <a:rPr lang="en-US" altLang="ja-JP" dirty="0" err="1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GF</a:t>
            </a:r>
            <a:r>
              <a:rPr lang="en-US" altLang="ja-JP" dirty="0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levels and age was observed in the discovery cohort, but not in the validation cohort. No significant sex differences were found in either cohort.</a:t>
            </a:r>
            <a:endParaRPr kumimoji="1" lang="ja-JP" altLang="en-US" dirty="0">
              <a:solidFill>
                <a:schemeClr val="tx2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7F0D29E-5111-C867-8511-E92F4FE19D6E}"/>
              </a:ext>
            </a:extLst>
          </p:cNvPr>
          <p:cNvSpPr txBox="1"/>
          <p:nvPr/>
        </p:nvSpPr>
        <p:spPr>
          <a:xfrm>
            <a:off x="0" y="559561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solidFill>
                  <a:schemeClr val="tx2"/>
                </a:solidFill>
              </a:rPr>
              <a:t>A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209E669-1047-1B0D-24F9-B63B87C5C361}"/>
              </a:ext>
            </a:extLst>
          </p:cNvPr>
          <p:cNvSpPr txBox="1"/>
          <p:nvPr/>
        </p:nvSpPr>
        <p:spPr>
          <a:xfrm>
            <a:off x="3366223" y="559561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solidFill>
                  <a:schemeClr val="tx2"/>
                </a:solidFill>
              </a:rPr>
              <a:t>B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2D67CFC-9D97-849A-0AA6-02B86EB13A4F}"/>
              </a:ext>
            </a:extLst>
          </p:cNvPr>
          <p:cNvSpPr txBox="1"/>
          <p:nvPr/>
        </p:nvSpPr>
        <p:spPr>
          <a:xfrm>
            <a:off x="6104365" y="559561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solidFill>
                  <a:schemeClr val="tx2"/>
                </a:solidFill>
              </a:rPr>
              <a:t>C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36422300-8386-9441-5159-DF65A9442011}"/>
              </a:ext>
            </a:extLst>
          </p:cNvPr>
          <p:cNvSpPr txBox="1"/>
          <p:nvPr/>
        </p:nvSpPr>
        <p:spPr>
          <a:xfrm>
            <a:off x="9452960" y="559561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solidFill>
                  <a:schemeClr val="tx2"/>
                </a:solidFill>
              </a:rPr>
              <a:t>D</a:t>
            </a:r>
          </a:p>
        </p:txBody>
      </p:sp>
      <p:pic>
        <p:nvPicPr>
          <p:cNvPr id="4" name="図 3" descr="図形&#10;&#10;AI 生成コンテンツは誤りを含む可能性があります。">
            <a:extLst>
              <a:ext uri="{FF2B5EF4-FFF2-40B4-BE49-F238E27FC236}">
                <a16:creationId xmlns:a16="http://schemas.microsoft.com/office/drawing/2014/main" id="{86FC58AF-0343-4A0D-997D-B69A8FB6F5F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839" r="6056"/>
          <a:stretch>
            <a:fillRect/>
          </a:stretch>
        </p:blipFill>
        <p:spPr>
          <a:xfrm>
            <a:off x="0" y="1119121"/>
            <a:ext cx="3599290" cy="3483683"/>
          </a:xfrm>
          <a:prstGeom prst="rect">
            <a:avLst/>
          </a:prstGeom>
        </p:spPr>
      </p:pic>
      <p:pic>
        <p:nvPicPr>
          <p:cNvPr id="8" name="図 7" descr="図形&#10;&#10;AI 生成コンテンツは誤りを含む可能性があります。">
            <a:extLst>
              <a:ext uri="{FF2B5EF4-FFF2-40B4-BE49-F238E27FC236}">
                <a16:creationId xmlns:a16="http://schemas.microsoft.com/office/drawing/2014/main" id="{CD502404-F6C4-B128-88B4-1540EA54FAB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839" r="6056"/>
          <a:stretch>
            <a:fillRect/>
          </a:stretch>
        </p:blipFill>
        <p:spPr>
          <a:xfrm>
            <a:off x="6108567" y="1119121"/>
            <a:ext cx="3599290" cy="3483684"/>
          </a:xfrm>
          <a:prstGeom prst="rect">
            <a:avLst/>
          </a:prstGeom>
        </p:spPr>
      </p:pic>
      <p:pic>
        <p:nvPicPr>
          <p:cNvPr id="17" name="図 16" descr="黒い背景に白い文字がある&#10;&#10;AI 生成コンテンツは誤りを含む可能性があります。">
            <a:extLst>
              <a:ext uri="{FF2B5EF4-FFF2-40B4-BE49-F238E27FC236}">
                <a16:creationId xmlns:a16="http://schemas.microsoft.com/office/drawing/2014/main" id="{5A90B78B-85C5-C88F-234E-E18A17552D7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220" r="13340"/>
          <a:stretch>
            <a:fillRect/>
          </a:stretch>
        </p:blipFill>
        <p:spPr>
          <a:xfrm>
            <a:off x="3366223" y="1119121"/>
            <a:ext cx="2730316" cy="3116858"/>
          </a:xfrm>
          <a:prstGeom prst="rect">
            <a:avLst/>
          </a:prstGeom>
        </p:spPr>
      </p:pic>
      <p:pic>
        <p:nvPicPr>
          <p:cNvPr id="19" name="図 18" descr="黒い背景に白い文字がある&#10;&#10;AI 生成コンテンツは誤りを含む可能性があります。">
            <a:extLst>
              <a:ext uri="{FF2B5EF4-FFF2-40B4-BE49-F238E27FC236}">
                <a16:creationId xmlns:a16="http://schemas.microsoft.com/office/drawing/2014/main" id="{B96532E5-9226-768D-9C4D-1B187CBC215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557" r="13340"/>
          <a:stretch>
            <a:fillRect/>
          </a:stretch>
        </p:blipFill>
        <p:spPr>
          <a:xfrm>
            <a:off x="9452960" y="1021225"/>
            <a:ext cx="2730317" cy="3214753"/>
          </a:xfrm>
          <a:prstGeom prst="rect">
            <a:avLst/>
          </a:prstGeom>
        </p:spPr>
      </p:pic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2E1D91C5-410F-2EE0-110D-4799A13E51D9}"/>
              </a:ext>
            </a:extLst>
          </p:cNvPr>
          <p:cNvSpPr txBox="1"/>
          <p:nvPr/>
        </p:nvSpPr>
        <p:spPr>
          <a:xfrm>
            <a:off x="940431" y="1214525"/>
            <a:ext cx="234230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>
                <a:solidFill>
                  <a:schemeClr val="tx2"/>
                </a:solidFill>
              </a:rPr>
              <a:t>r </a:t>
            </a:r>
            <a:r>
              <a:rPr kumimoji="1" lang="en-US" altLang="ja-JP" sz="1400" dirty="0">
                <a:solidFill>
                  <a:schemeClr val="tx2"/>
                </a:solidFill>
              </a:rPr>
              <a:t>= 0.467 (95%CI 0.292-0.612)</a:t>
            </a:r>
          </a:p>
          <a:p>
            <a:r>
              <a:rPr lang="en-US" altLang="ja-JP" sz="1400" i="1" dirty="0">
                <a:solidFill>
                  <a:schemeClr val="tx2"/>
                </a:solidFill>
              </a:rPr>
              <a:t>p</a:t>
            </a:r>
            <a:r>
              <a:rPr lang="en-US" altLang="ja-JP" sz="1400" dirty="0">
                <a:solidFill>
                  <a:schemeClr val="tx2"/>
                </a:solidFill>
              </a:rPr>
              <a:t> &lt; 0.0001</a:t>
            </a:r>
            <a:endParaRPr kumimoji="1" lang="ja-JP" altLang="en-US" sz="1400" dirty="0">
              <a:solidFill>
                <a:schemeClr val="tx2"/>
              </a:solidFill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6C063E9C-23BE-26F4-61B6-F690AE96480D}"/>
              </a:ext>
            </a:extLst>
          </p:cNvPr>
          <p:cNvSpPr txBox="1"/>
          <p:nvPr/>
        </p:nvSpPr>
        <p:spPr>
          <a:xfrm>
            <a:off x="4683253" y="1214525"/>
            <a:ext cx="8178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i="1" dirty="0">
                <a:solidFill>
                  <a:schemeClr val="tx2"/>
                </a:solidFill>
              </a:rPr>
              <a:t>p</a:t>
            </a:r>
            <a:r>
              <a:rPr lang="en-US" altLang="ja-JP" sz="1400" dirty="0">
                <a:solidFill>
                  <a:schemeClr val="tx2"/>
                </a:solidFill>
              </a:rPr>
              <a:t> =0.172</a:t>
            </a:r>
            <a:endParaRPr kumimoji="1" lang="ja-JP" altLang="en-US" sz="1400" dirty="0">
              <a:solidFill>
                <a:schemeClr val="tx2"/>
              </a:solidFill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DB4AF804-F3F6-4701-1110-29A7A49D3550}"/>
              </a:ext>
            </a:extLst>
          </p:cNvPr>
          <p:cNvSpPr txBox="1"/>
          <p:nvPr/>
        </p:nvSpPr>
        <p:spPr>
          <a:xfrm>
            <a:off x="7032788" y="1214525"/>
            <a:ext cx="239681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>
                <a:solidFill>
                  <a:schemeClr val="tx2"/>
                </a:solidFill>
              </a:rPr>
              <a:t>r </a:t>
            </a:r>
            <a:r>
              <a:rPr kumimoji="1" lang="en-US" altLang="ja-JP" sz="1400" dirty="0">
                <a:solidFill>
                  <a:schemeClr val="tx2"/>
                </a:solidFill>
              </a:rPr>
              <a:t>= 0.128 (95%CI -0.</a:t>
            </a:r>
            <a:r>
              <a:rPr lang="en-US" altLang="ja-JP" sz="1400" dirty="0">
                <a:solidFill>
                  <a:schemeClr val="tx2"/>
                </a:solidFill>
              </a:rPr>
              <a:t>153</a:t>
            </a:r>
            <a:r>
              <a:rPr kumimoji="1" lang="en-US" altLang="ja-JP" sz="1400" dirty="0">
                <a:solidFill>
                  <a:schemeClr val="tx2"/>
                </a:solidFill>
              </a:rPr>
              <a:t>-0.</a:t>
            </a:r>
            <a:r>
              <a:rPr lang="en-US" altLang="ja-JP" sz="1400" dirty="0">
                <a:solidFill>
                  <a:schemeClr val="tx2"/>
                </a:solidFill>
              </a:rPr>
              <a:t>389</a:t>
            </a:r>
            <a:r>
              <a:rPr kumimoji="1" lang="en-US" altLang="ja-JP" sz="1400" dirty="0">
                <a:solidFill>
                  <a:schemeClr val="tx2"/>
                </a:solidFill>
              </a:rPr>
              <a:t>)</a:t>
            </a:r>
          </a:p>
          <a:p>
            <a:r>
              <a:rPr lang="en-US" altLang="ja-JP" sz="1400" i="1" dirty="0">
                <a:solidFill>
                  <a:schemeClr val="tx2"/>
                </a:solidFill>
              </a:rPr>
              <a:t>p</a:t>
            </a:r>
            <a:r>
              <a:rPr lang="en-US" altLang="ja-JP" sz="1400" dirty="0">
                <a:solidFill>
                  <a:schemeClr val="tx2"/>
                </a:solidFill>
              </a:rPr>
              <a:t> = 0.358</a:t>
            </a:r>
            <a:endParaRPr kumimoji="1" lang="ja-JP" altLang="en-US" sz="1400" dirty="0">
              <a:solidFill>
                <a:schemeClr val="tx2"/>
              </a:solidFill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E6E84ABE-7B5D-D41C-C7A9-8D7A0665DD63}"/>
              </a:ext>
            </a:extLst>
          </p:cNvPr>
          <p:cNvSpPr txBox="1"/>
          <p:nvPr/>
        </p:nvSpPr>
        <p:spPr>
          <a:xfrm>
            <a:off x="10775610" y="1214525"/>
            <a:ext cx="8178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i="1" dirty="0">
                <a:solidFill>
                  <a:schemeClr val="tx2"/>
                </a:solidFill>
              </a:rPr>
              <a:t>p</a:t>
            </a:r>
            <a:r>
              <a:rPr lang="en-US" altLang="ja-JP" sz="1400" dirty="0">
                <a:solidFill>
                  <a:schemeClr val="tx2"/>
                </a:solidFill>
              </a:rPr>
              <a:t> =0.370</a:t>
            </a:r>
            <a:endParaRPr kumimoji="1" lang="ja-JP" altLang="en-US" sz="1400" dirty="0">
              <a:solidFill>
                <a:schemeClr val="tx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557449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C87935F-48A6-B181-5918-9C0631CDFCF7}"/>
              </a:ext>
            </a:extLst>
          </p:cNvPr>
          <p:cNvSpPr txBox="1"/>
          <p:nvPr/>
        </p:nvSpPr>
        <p:spPr>
          <a:xfrm>
            <a:off x="0" y="6257836"/>
            <a:ext cx="11983453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100" b="1" dirty="0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ja-JP" altLang="en-US" sz="1100" b="1" dirty="0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100" b="1" dirty="0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2. CSF biomarkers-WMH volume association.</a:t>
            </a:r>
          </a:p>
          <a:p>
            <a:pPr algn="just"/>
            <a:r>
              <a:rPr lang="en-US" altLang="ja-JP" sz="1100" dirty="0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catter plots illustrate the relationship between CSF biomarker levels and WMH volume in AD+ (red) and non-AD (blue) groups. Regression lines (solid) and 95% confidence intervals (dashed) are shown. Panels represent: (A) CSF </a:t>
            </a:r>
            <a:r>
              <a:rPr lang="en-US" altLang="ja-JP" sz="1100" dirty="0" err="1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fL</a:t>
            </a:r>
            <a:r>
              <a:rPr lang="en-US" altLang="ja-JP" sz="1100" dirty="0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(B) CSF Aβ40, (C) CSF Aβ42, and (D) CSF p-tau181. Significant associations with WMH volume were observed only in the AD+ group for CSF </a:t>
            </a:r>
            <a:r>
              <a:rPr lang="en-US" altLang="ja-JP" sz="1100" dirty="0" err="1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fL</a:t>
            </a:r>
            <a:r>
              <a:rPr lang="en-US" altLang="ja-JP" sz="1100" dirty="0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CSF p-tau181.</a:t>
            </a:r>
            <a:endParaRPr kumimoji="1" lang="ja-JP" altLang="en-US" sz="1100" dirty="0">
              <a:solidFill>
                <a:schemeClr val="tx2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42803804-3C61-C395-3671-096D1A1B4110}"/>
              </a:ext>
            </a:extLst>
          </p:cNvPr>
          <p:cNvSpPr txBox="1"/>
          <p:nvPr/>
        </p:nvSpPr>
        <p:spPr>
          <a:xfrm>
            <a:off x="0" y="-5933"/>
            <a:ext cx="14574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solidFill>
                  <a:schemeClr val="tx2"/>
                </a:solidFill>
              </a:rPr>
              <a:t>A  CSF </a:t>
            </a:r>
            <a:r>
              <a:rPr kumimoji="1" lang="en-US" altLang="ja-JP" sz="2400" b="1" dirty="0" err="1">
                <a:solidFill>
                  <a:schemeClr val="tx2"/>
                </a:solidFill>
              </a:rPr>
              <a:t>NfL</a:t>
            </a:r>
            <a:endParaRPr kumimoji="1" lang="en-US" altLang="ja-JP" sz="2400" b="1" dirty="0">
              <a:solidFill>
                <a:schemeClr val="tx2"/>
              </a:solidFill>
            </a:endParaRPr>
          </a:p>
        </p:txBody>
      </p:sp>
      <p:pic>
        <p:nvPicPr>
          <p:cNvPr id="10" name="図 9" descr="ゲームの画面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0011CBA5-7C40-368E-718D-F45E752B9C3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433714" y="-5933"/>
            <a:ext cx="1232850" cy="781852"/>
          </a:xfrm>
          <a:prstGeom prst="rect">
            <a:avLst/>
          </a:prstGeom>
        </p:spPr>
      </p:pic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C55F10EB-DBEA-C2A6-09D8-979C5A641CE4}"/>
              </a:ext>
            </a:extLst>
          </p:cNvPr>
          <p:cNvSpPr txBox="1"/>
          <p:nvPr/>
        </p:nvSpPr>
        <p:spPr>
          <a:xfrm>
            <a:off x="4404093" y="3103678"/>
            <a:ext cx="218380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solidFill>
                  <a:schemeClr val="tx2"/>
                </a:solidFill>
              </a:rPr>
              <a:t>D  CSF p-tau181</a:t>
            </a:r>
            <a:endParaRPr kumimoji="1" lang="en-US" altLang="ja-JP" sz="2400" b="1" dirty="0">
              <a:solidFill>
                <a:schemeClr val="tx2"/>
              </a:solidFill>
            </a:endParaRPr>
          </a:p>
        </p:txBody>
      </p:sp>
      <p:pic>
        <p:nvPicPr>
          <p:cNvPr id="8" name="図 7" descr="夜の街のイラスト&#10;&#10;AI 生成コンテンツは誤りを含む可能性があります。">
            <a:extLst>
              <a:ext uri="{FF2B5EF4-FFF2-40B4-BE49-F238E27FC236}">
                <a16:creationId xmlns:a16="http://schemas.microsoft.com/office/drawing/2014/main" id="{885245E8-B661-55CF-532D-25E32580C88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4404093" y="3607369"/>
            <a:ext cx="3646046" cy="2658526"/>
          </a:xfrm>
          <a:prstGeom prst="rect">
            <a:avLst/>
          </a:prstGeom>
        </p:spPr>
      </p:pic>
      <p:pic>
        <p:nvPicPr>
          <p:cNvPr id="21" name="図 20" descr="ゲームの画面&#10;&#10;AI 生成コンテンツは誤りを含む可能性があります。">
            <a:extLst>
              <a:ext uri="{FF2B5EF4-FFF2-40B4-BE49-F238E27FC236}">
                <a16:creationId xmlns:a16="http://schemas.microsoft.com/office/drawing/2014/main" id="{7083936F-1189-AFC8-25EE-BC627175C35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4404093" y="457187"/>
            <a:ext cx="3646046" cy="2658524"/>
          </a:xfrm>
          <a:prstGeom prst="rect">
            <a:avLst/>
          </a:prstGeom>
        </p:spPr>
      </p:pic>
      <p:pic>
        <p:nvPicPr>
          <p:cNvPr id="23" name="図 22" descr="コンピューターゲームの画面&#10;&#10;AI 生成コンテンツは誤りを含む可能性があります。">
            <a:extLst>
              <a:ext uri="{FF2B5EF4-FFF2-40B4-BE49-F238E27FC236}">
                <a16:creationId xmlns:a16="http://schemas.microsoft.com/office/drawing/2014/main" id="{E3F708E5-6160-1C71-3A5E-4EA3ED88D43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0" y="3607369"/>
            <a:ext cx="3646046" cy="2658525"/>
          </a:xfrm>
          <a:prstGeom prst="rect">
            <a:avLst/>
          </a:prstGeom>
        </p:spPr>
      </p:pic>
      <p:pic>
        <p:nvPicPr>
          <p:cNvPr id="25" name="図 24" descr="光, ノートパソコン, 座る, コンピュータ が含まれている画像&#10;&#10;AI 生成コンテンツは誤りを含む可能性があります。">
            <a:extLst>
              <a:ext uri="{FF2B5EF4-FFF2-40B4-BE49-F238E27FC236}">
                <a16:creationId xmlns:a16="http://schemas.microsoft.com/office/drawing/2014/main" id="{09B6AFA2-309D-8E11-2E60-7F7C032EDA7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0" y="457187"/>
            <a:ext cx="3629261" cy="2658524"/>
          </a:xfrm>
          <a:prstGeom prst="rect">
            <a:avLst/>
          </a:prstGeom>
        </p:spPr>
      </p:pic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F4B3C3BE-E27D-7E2D-8C81-55EB9E8D4E3F}"/>
              </a:ext>
            </a:extLst>
          </p:cNvPr>
          <p:cNvSpPr txBox="1"/>
          <p:nvPr/>
        </p:nvSpPr>
        <p:spPr>
          <a:xfrm>
            <a:off x="4404093" y="-5933"/>
            <a:ext cx="168026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solidFill>
                  <a:schemeClr val="tx2"/>
                </a:solidFill>
              </a:rPr>
              <a:t>B  CSF Aβ40</a:t>
            </a: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BE11D1BC-DB5F-0C23-E448-E89BE4875DBE}"/>
              </a:ext>
            </a:extLst>
          </p:cNvPr>
          <p:cNvSpPr txBox="1"/>
          <p:nvPr/>
        </p:nvSpPr>
        <p:spPr>
          <a:xfrm>
            <a:off x="0" y="3103678"/>
            <a:ext cx="168026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solidFill>
                  <a:schemeClr val="tx2"/>
                </a:solidFill>
              </a:rPr>
              <a:t>C  CSF Aβ42</a:t>
            </a: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EA41FBB4-CDCE-A618-4A4C-5E60077344B9}"/>
              </a:ext>
            </a:extLst>
          </p:cNvPr>
          <p:cNvSpPr txBox="1"/>
          <p:nvPr/>
        </p:nvSpPr>
        <p:spPr>
          <a:xfrm>
            <a:off x="1275822" y="1859728"/>
            <a:ext cx="3206327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altLang="ja-JP" sz="1600" dirty="0">
                <a:solidFill>
                  <a:srgbClr val="FF0000"/>
                </a:solidFill>
              </a:rPr>
              <a:t>AD+</a:t>
            </a:r>
            <a:r>
              <a:rPr lang="pt-BR" altLang="ja-JP" sz="1600" dirty="0">
                <a:solidFill>
                  <a:schemeClr val="tx2"/>
                </a:solidFill>
              </a:rPr>
              <a:t>: </a:t>
            </a:r>
            <a:r>
              <a:rPr lang="pt-BR" altLang="ja-JP" sz="1600" b="1" dirty="0">
                <a:solidFill>
                  <a:schemeClr val="tx2"/>
                </a:solidFill>
              </a:rPr>
              <a:t>slope = 0.00136, </a:t>
            </a:r>
            <a:r>
              <a:rPr lang="pt-BR" altLang="ja-JP" sz="1600" b="1" i="1" dirty="0">
                <a:solidFill>
                  <a:schemeClr val="tx2"/>
                </a:solidFill>
              </a:rPr>
              <a:t>p</a:t>
            </a:r>
            <a:r>
              <a:rPr lang="pt-BR" altLang="ja-JP" sz="1600" b="1" dirty="0">
                <a:solidFill>
                  <a:schemeClr val="tx2"/>
                </a:solidFill>
              </a:rPr>
              <a:t> = 0.020</a:t>
            </a:r>
            <a:br>
              <a:rPr lang="pt-BR" altLang="ja-JP" sz="1600" dirty="0">
                <a:solidFill>
                  <a:schemeClr val="tx2"/>
                </a:solidFill>
              </a:rPr>
            </a:br>
            <a:r>
              <a:rPr lang="pt-BR" altLang="ja-JP" sz="1600" dirty="0">
                <a:solidFill>
                  <a:srgbClr val="0000FF"/>
                </a:solidFill>
              </a:rPr>
              <a:t>non-AD</a:t>
            </a:r>
            <a:r>
              <a:rPr lang="pt-BR" altLang="ja-JP" sz="1600" dirty="0">
                <a:solidFill>
                  <a:schemeClr val="tx2"/>
                </a:solidFill>
              </a:rPr>
              <a:t>: slope = 0.000419, </a:t>
            </a:r>
            <a:r>
              <a:rPr lang="pt-BR" altLang="ja-JP" sz="1600" i="1" dirty="0">
                <a:solidFill>
                  <a:schemeClr val="tx2"/>
                </a:solidFill>
              </a:rPr>
              <a:t>p</a:t>
            </a:r>
            <a:r>
              <a:rPr lang="pt-BR" altLang="ja-JP" sz="1600" dirty="0">
                <a:solidFill>
                  <a:schemeClr val="tx2"/>
                </a:solidFill>
              </a:rPr>
              <a:t> = 0.061</a:t>
            </a:r>
            <a:endParaRPr kumimoji="1" lang="ja-JP" altLang="en-US" sz="1600" dirty="0">
              <a:solidFill>
                <a:schemeClr val="tx2"/>
              </a:solidFill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77B65066-D91F-EDDD-AE83-A20E7048AAA2}"/>
              </a:ext>
            </a:extLst>
          </p:cNvPr>
          <p:cNvSpPr txBox="1"/>
          <p:nvPr/>
        </p:nvSpPr>
        <p:spPr>
          <a:xfrm>
            <a:off x="7219961" y="1239039"/>
            <a:ext cx="316464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altLang="ja-JP" sz="1600" dirty="0">
                <a:solidFill>
                  <a:srgbClr val="FF0000"/>
                </a:solidFill>
              </a:rPr>
              <a:t>AD+</a:t>
            </a:r>
            <a:r>
              <a:rPr lang="pt-BR" altLang="ja-JP" sz="1600" dirty="0">
                <a:solidFill>
                  <a:schemeClr val="tx2"/>
                </a:solidFill>
              </a:rPr>
              <a:t>: slope = -0.00217, </a:t>
            </a:r>
            <a:r>
              <a:rPr lang="pt-BR" altLang="ja-JP" sz="1600" i="1" dirty="0">
                <a:solidFill>
                  <a:schemeClr val="tx2"/>
                </a:solidFill>
              </a:rPr>
              <a:t>p</a:t>
            </a:r>
            <a:r>
              <a:rPr lang="pt-BR" altLang="ja-JP" sz="1600" dirty="0">
                <a:solidFill>
                  <a:schemeClr val="tx2"/>
                </a:solidFill>
              </a:rPr>
              <a:t> = 0.113</a:t>
            </a:r>
            <a:br>
              <a:rPr lang="pt-BR" altLang="ja-JP" sz="1600" dirty="0">
                <a:solidFill>
                  <a:schemeClr val="tx2"/>
                </a:solidFill>
              </a:rPr>
            </a:br>
            <a:r>
              <a:rPr lang="pt-BR" altLang="ja-JP" sz="1600" dirty="0">
                <a:solidFill>
                  <a:srgbClr val="0000FF"/>
                </a:solidFill>
              </a:rPr>
              <a:t>non-AD</a:t>
            </a:r>
            <a:r>
              <a:rPr lang="pt-BR" altLang="ja-JP" sz="1600" dirty="0">
                <a:solidFill>
                  <a:schemeClr val="tx2"/>
                </a:solidFill>
              </a:rPr>
              <a:t>: slope = -0.00309, </a:t>
            </a:r>
            <a:r>
              <a:rPr lang="pt-BR" altLang="ja-JP" sz="1600" i="1" dirty="0">
                <a:solidFill>
                  <a:schemeClr val="tx2"/>
                </a:solidFill>
              </a:rPr>
              <a:t>p</a:t>
            </a:r>
            <a:r>
              <a:rPr lang="pt-BR" altLang="ja-JP" sz="1600" dirty="0">
                <a:solidFill>
                  <a:schemeClr val="tx2"/>
                </a:solidFill>
              </a:rPr>
              <a:t> = 0.216</a:t>
            </a:r>
            <a:endParaRPr kumimoji="1" lang="ja-JP" altLang="en-US" sz="1600" dirty="0">
              <a:solidFill>
                <a:schemeClr val="tx2"/>
              </a:solidFill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F9201139-E0CB-DF24-864E-68F8B68AFA7D}"/>
              </a:ext>
            </a:extLst>
          </p:cNvPr>
          <p:cNvSpPr txBox="1"/>
          <p:nvPr/>
        </p:nvSpPr>
        <p:spPr>
          <a:xfrm>
            <a:off x="1432238" y="3483993"/>
            <a:ext cx="316464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altLang="ja-JP" sz="1600" dirty="0">
                <a:solidFill>
                  <a:srgbClr val="FF0000"/>
                </a:solidFill>
              </a:rPr>
              <a:t>AD+</a:t>
            </a:r>
            <a:r>
              <a:rPr lang="pt-BR" altLang="ja-JP" sz="1600" dirty="0">
                <a:solidFill>
                  <a:schemeClr val="tx2"/>
                </a:solidFill>
              </a:rPr>
              <a:t>: slope = -0.0223, </a:t>
            </a:r>
            <a:r>
              <a:rPr lang="pt-BR" altLang="ja-JP" sz="1600" i="1" dirty="0">
                <a:solidFill>
                  <a:schemeClr val="tx2"/>
                </a:solidFill>
              </a:rPr>
              <a:t>p</a:t>
            </a:r>
            <a:r>
              <a:rPr lang="pt-BR" altLang="ja-JP" sz="1600" dirty="0">
                <a:solidFill>
                  <a:schemeClr val="tx2"/>
                </a:solidFill>
              </a:rPr>
              <a:t> = 0.291</a:t>
            </a:r>
            <a:br>
              <a:rPr lang="pt-BR" altLang="ja-JP" sz="1600" dirty="0">
                <a:solidFill>
                  <a:schemeClr val="tx2"/>
                </a:solidFill>
              </a:rPr>
            </a:br>
            <a:r>
              <a:rPr lang="pt-BR" altLang="ja-JP" sz="1600" dirty="0">
                <a:solidFill>
                  <a:srgbClr val="0000FF"/>
                </a:solidFill>
              </a:rPr>
              <a:t>non-AD</a:t>
            </a:r>
            <a:r>
              <a:rPr lang="pt-BR" altLang="ja-JP" sz="1600" dirty="0">
                <a:solidFill>
                  <a:schemeClr val="tx2"/>
                </a:solidFill>
              </a:rPr>
              <a:t>: slope = -0.0441, </a:t>
            </a:r>
            <a:r>
              <a:rPr lang="pt-BR" altLang="ja-JP" sz="1600" i="1" dirty="0">
                <a:solidFill>
                  <a:schemeClr val="tx2"/>
                </a:solidFill>
              </a:rPr>
              <a:t>p</a:t>
            </a:r>
            <a:r>
              <a:rPr lang="pt-BR" altLang="ja-JP" sz="1600" dirty="0">
                <a:solidFill>
                  <a:schemeClr val="tx2"/>
                </a:solidFill>
              </a:rPr>
              <a:t> = 0.089</a:t>
            </a:r>
            <a:endParaRPr kumimoji="1" lang="ja-JP" altLang="en-US" sz="1600" dirty="0">
              <a:solidFill>
                <a:schemeClr val="tx2"/>
              </a:solidFill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8E3476A8-DD58-2792-D6FA-B20646B08C25}"/>
              </a:ext>
            </a:extLst>
          </p:cNvPr>
          <p:cNvSpPr txBox="1"/>
          <p:nvPr/>
        </p:nvSpPr>
        <p:spPr>
          <a:xfrm>
            <a:off x="6261585" y="3565343"/>
            <a:ext cx="295625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altLang="ja-JP" sz="1600" dirty="0">
                <a:solidFill>
                  <a:srgbClr val="FF0000"/>
                </a:solidFill>
              </a:rPr>
              <a:t>AD+</a:t>
            </a:r>
            <a:r>
              <a:rPr lang="pt-BR" altLang="ja-JP" sz="1600" dirty="0">
                <a:solidFill>
                  <a:schemeClr val="tx2"/>
                </a:solidFill>
              </a:rPr>
              <a:t>: </a:t>
            </a:r>
            <a:r>
              <a:rPr lang="pt-BR" altLang="ja-JP" sz="1600" b="1" dirty="0">
                <a:solidFill>
                  <a:schemeClr val="tx2"/>
                </a:solidFill>
              </a:rPr>
              <a:t>slope = -0.167, </a:t>
            </a:r>
            <a:r>
              <a:rPr lang="pt-BR" altLang="ja-JP" sz="1600" b="1" i="1" dirty="0">
                <a:solidFill>
                  <a:schemeClr val="tx2"/>
                </a:solidFill>
              </a:rPr>
              <a:t>p</a:t>
            </a:r>
            <a:r>
              <a:rPr lang="pt-BR" altLang="ja-JP" sz="1600" b="1" dirty="0">
                <a:solidFill>
                  <a:schemeClr val="tx2"/>
                </a:solidFill>
              </a:rPr>
              <a:t> = 0.012</a:t>
            </a:r>
            <a:br>
              <a:rPr lang="pt-BR" altLang="ja-JP" sz="1600" dirty="0">
                <a:solidFill>
                  <a:schemeClr val="tx2"/>
                </a:solidFill>
              </a:rPr>
            </a:br>
            <a:r>
              <a:rPr lang="pt-BR" altLang="ja-JP" sz="1600" dirty="0">
                <a:solidFill>
                  <a:srgbClr val="0000FF"/>
                </a:solidFill>
              </a:rPr>
              <a:t>non-AD</a:t>
            </a:r>
            <a:r>
              <a:rPr lang="pt-BR" altLang="ja-JP" sz="1600" dirty="0">
                <a:solidFill>
                  <a:schemeClr val="tx2"/>
                </a:solidFill>
              </a:rPr>
              <a:t>: slope = -0.142, </a:t>
            </a:r>
            <a:r>
              <a:rPr lang="pt-BR" altLang="ja-JP" sz="1600" i="1" dirty="0">
                <a:solidFill>
                  <a:schemeClr val="tx2"/>
                </a:solidFill>
              </a:rPr>
              <a:t>p</a:t>
            </a:r>
            <a:r>
              <a:rPr lang="pt-BR" altLang="ja-JP" sz="1600" dirty="0">
                <a:solidFill>
                  <a:schemeClr val="tx2"/>
                </a:solidFill>
              </a:rPr>
              <a:t> = 0.585</a:t>
            </a:r>
            <a:endParaRPr kumimoji="1" lang="ja-JP" altLang="en-US" sz="1600" dirty="0">
              <a:solidFill>
                <a:schemeClr val="tx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029317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627C1CD-3638-EBE6-709A-56230AE4D97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図形&#10;&#10;中程度の精度で自動的に生成された説明">
            <a:extLst>
              <a:ext uri="{FF2B5EF4-FFF2-40B4-BE49-F238E27FC236}">
                <a16:creationId xmlns:a16="http://schemas.microsoft.com/office/drawing/2014/main" id="{86822EED-9C3C-8C2B-D5FE-17C022B079C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588577" y="239563"/>
            <a:ext cx="5055288" cy="3743325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5273EF8D-B15C-D5E5-B2D1-18C371913AE1}"/>
              </a:ext>
            </a:extLst>
          </p:cNvPr>
          <p:cNvSpPr txBox="1"/>
          <p:nvPr/>
        </p:nvSpPr>
        <p:spPr>
          <a:xfrm>
            <a:off x="5067582" y="3954875"/>
            <a:ext cx="236705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800" b="1" dirty="0">
                <a:solidFill>
                  <a:schemeClr val="tx2"/>
                </a:solidFill>
              </a:rPr>
              <a:t>DSWMH grade</a:t>
            </a:r>
            <a:endParaRPr kumimoji="1" lang="ja-JP" altLang="en-US" sz="2800" b="1" dirty="0">
              <a:solidFill>
                <a:schemeClr val="tx2"/>
              </a:solidFill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D8DB658-D7AF-CF6F-86D2-EF8A54A10B01}"/>
              </a:ext>
            </a:extLst>
          </p:cNvPr>
          <p:cNvSpPr txBox="1"/>
          <p:nvPr/>
        </p:nvSpPr>
        <p:spPr>
          <a:xfrm rot="16200000">
            <a:off x="1837635" y="1677747"/>
            <a:ext cx="293048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800" b="1" dirty="0">
                <a:solidFill>
                  <a:schemeClr val="tx2"/>
                </a:solidFill>
              </a:rPr>
              <a:t>WMH volume (ml)</a:t>
            </a:r>
            <a:endParaRPr kumimoji="1" lang="ja-JP" altLang="en-US" sz="2800" b="1" dirty="0">
              <a:solidFill>
                <a:schemeClr val="tx2"/>
              </a:solidFill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2FF56F6-1A0D-F1BA-7F27-D6E57C74DFF6}"/>
              </a:ext>
            </a:extLst>
          </p:cNvPr>
          <p:cNvSpPr txBox="1"/>
          <p:nvPr/>
        </p:nvSpPr>
        <p:spPr>
          <a:xfrm>
            <a:off x="4251964" y="375504"/>
            <a:ext cx="295946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>
                <a:solidFill>
                  <a:schemeClr val="tx2"/>
                </a:solidFill>
              </a:rPr>
              <a:t>r </a:t>
            </a:r>
            <a:r>
              <a:rPr kumimoji="1" lang="en-US" altLang="ja-JP" dirty="0">
                <a:solidFill>
                  <a:schemeClr val="tx2"/>
                </a:solidFill>
              </a:rPr>
              <a:t>= 0.711 (95%CI 0.594-0.799)</a:t>
            </a:r>
          </a:p>
          <a:p>
            <a:r>
              <a:rPr lang="en-US" altLang="ja-JP" i="1" dirty="0">
                <a:solidFill>
                  <a:schemeClr val="tx2"/>
                </a:solidFill>
              </a:rPr>
              <a:t>p</a:t>
            </a:r>
            <a:r>
              <a:rPr lang="en-US" altLang="ja-JP" dirty="0">
                <a:solidFill>
                  <a:schemeClr val="tx2"/>
                </a:solidFill>
              </a:rPr>
              <a:t> &lt; 0.0001</a:t>
            </a:r>
            <a:endParaRPr kumimoji="1" lang="ja-JP" altLang="en-US" dirty="0">
              <a:solidFill>
                <a:schemeClr val="tx2"/>
              </a:solidFill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D20AABF-1952-37B1-EDAB-DC30A11B982E}"/>
              </a:ext>
            </a:extLst>
          </p:cNvPr>
          <p:cNvSpPr txBox="1"/>
          <p:nvPr/>
        </p:nvSpPr>
        <p:spPr>
          <a:xfrm>
            <a:off x="1" y="4670262"/>
            <a:ext cx="1219199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b="1" dirty="0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ja-JP" altLang="en-US" b="1" dirty="0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b="1" dirty="0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3. Significant correlation between DSWMH grading and WMH volume.</a:t>
            </a:r>
          </a:p>
          <a:p>
            <a:pPr algn="just"/>
            <a:r>
              <a:rPr lang="en-US" altLang="ja-JP" dirty="0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correlation between deep and subcortical white matter hyperintensity (DSWMH) grading and white matter hyperintensity (WMH) volume was analyzed using Spearman's rank correlation coefficient and was found to be significant.</a:t>
            </a:r>
            <a:endParaRPr kumimoji="1" lang="ja-JP" altLang="en-US" dirty="0">
              <a:solidFill>
                <a:schemeClr val="tx2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853374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898F69A-E2C9-FCA2-7C4D-17C634CE852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73576DE-5448-F891-5A85-2BBB3DE6CF4D}"/>
              </a:ext>
            </a:extLst>
          </p:cNvPr>
          <p:cNvSpPr txBox="1"/>
          <p:nvPr/>
        </p:nvSpPr>
        <p:spPr>
          <a:xfrm>
            <a:off x="0" y="5934670"/>
            <a:ext cx="121920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b="1" dirty="0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. Comparison of plasma </a:t>
            </a:r>
            <a:r>
              <a:rPr lang="en-US" altLang="ja-JP" b="1" dirty="0" err="1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GF</a:t>
            </a:r>
            <a:r>
              <a:rPr lang="en-US" altLang="ja-JP" b="1" dirty="0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levels across BMI categories. </a:t>
            </a:r>
          </a:p>
          <a:p>
            <a:pPr algn="just"/>
            <a:r>
              <a:rPr lang="en-US" altLang="ja-JP" dirty="0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rticipants were stratified into three BMI groups: underweight (&lt;18.5), normal (18.5–24.9), and overweight (≥25.0). Plasma </a:t>
            </a:r>
            <a:r>
              <a:rPr lang="en-US" altLang="ja-JP" dirty="0" err="1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GF</a:t>
            </a:r>
            <a:r>
              <a:rPr lang="en-US" altLang="ja-JP" dirty="0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levels were compared using the Kruskal–Wallis test. No significant differences were observed among the groups (</a:t>
            </a:r>
            <a:r>
              <a:rPr lang="en-US" altLang="ja-JP" i="1" dirty="0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dirty="0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= 0.133).</a:t>
            </a:r>
            <a:endParaRPr kumimoji="1" lang="ja-JP" altLang="en-US" dirty="0">
              <a:solidFill>
                <a:schemeClr val="tx2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図 3" descr="黒い背景に白い文字がある&#10;&#10;AI 生成コンテンツは誤りを含む可能性があります。">
            <a:extLst>
              <a:ext uri="{FF2B5EF4-FFF2-40B4-BE49-F238E27FC236}">
                <a16:creationId xmlns:a16="http://schemas.microsoft.com/office/drawing/2014/main" id="{6445610C-9E25-7E2B-68DB-0F5983085B4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271"/>
          <a:stretch>
            <a:fillRect/>
          </a:stretch>
        </p:blipFill>
        <p:spPr>
          <a:xfrm>
            <a:off x="3647500" y="427149"/>
            <a:ext cx="3958532" cy="55062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2376758"/>
      </p:ext>
    </p:extLst>
  </p:cSld>
  <p:clrMapOvr>
    <a:masterClrMapping/>
  </p:clrMapOvr>
</p:sld>
</file>

<file path=ppt/theme/theme1.xml><?xml version="1.0" encoding="utf-8"?>
<a:theme xmlns:a="http://schemas.openxmlformats.org/drawingml/2006/main" name="パワーポイントデザイン_20231103">
  <a:themeElements>
    <a:clrScheme name="20231103">
      <a:dk1>
        <a:srgbClr val="6F6F6F"/>
      </a:dk1>
      <a:lt1>
        <a:sysClr val="window" lastClr="FFFFFF"/>
      </a:lt1>
      <a:dk2>
        <a:srgbClr val="000000"/>
      </a:dk2>
      <a:lt2>
        <a:srgbClr val="FFFFFF"/>
      </a:lt2>
      <a:accent1>
        <a:srgbClr val="FE6400"/>
      </a:accent1>
      <a:accent2>
        <a:srgbClr val="0096FA"/>
      </a:accent2>
      <a:accent3>
        <a:srgbClr val="00B900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20231103">
      <a:majorFont>
        <a:latin typeface="Calibri"/>
        <a:ea typeface="HG丸ｺﾞｼｯｸM-PRO"/>
        <a:cs typeface=""/>
      </a:majorFont>
      <a:minorFont>
        <a:latin typeface="Calibri"/>
        <a:ea typeface="HG丸ｺﾞｼｯｸM-PRO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パワーポイントデザイン_20231103" id="{90D115D7-56BA-448D-BD0C-280549E29CA0}" vid="{12639D4F-EC86-4841-85FB-C452452C5F50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パワーポイントデザイン_20231103</Template>
  <TotalTime>195</TotalTime>
  <Words>439</Words>
  <Application>Microsoft Office PowerPoint</Application>
  <PresentationFormat>Widescreen</PresentationFormat>
  <Paragraphs>34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游ゴシック</vt:lpstr>
      <vt:lpstr>Arial</vt:lpstr>
      <vt:lpstr>Calibri</vt:lpstr>
      <vt:lpstr>Times New Roman</vt:lpstr>
      <vt:lpstr>パワーポイントデザイン_20231103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nsaku Kasuga</dc:creator>
  <cp:lastModifiedBy>MDPI</cp:lastModifiedBy>
  <cp:revision>5</cp:revision>
  <cp:lastPrinted>2025-09-22T09:43:27Z</cp:lastPrinted>
  <dcterms:created xsi:type="dcterms:W3CDTF">2025-02-02T05:54:07Z</dcterms:created>
  <dcterms:modified xsi:type="dcterms:W3CDTF">2025-09-26T09:32:45Z</dcterms:modified>
</cp:coreProperties>
</file>